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05990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09203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55661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41859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35891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249823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40025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45216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248031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97667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22998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C41EA-5D63-45EC-9F8E-95A7EBB1C24E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A9B900-7611-4581-BFFE-BDAD47FD9EFD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436654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9325" y="642937"/>
            <a:ext cx="7753350" cy="557212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5433391" y="5753397"/>
            <a:ext cx="267694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BMI (Kg/m</a:t>
            </a:r>
            <a:r>
              <a:rPr lang="es-CL" sz="2400" baseline="30000" dirty="0"/>
              <a:t>2</a:t>
            </a:r>
            <a:r>
              <a:rPr lang="es-CL" sz="2400" dirty="0"/>
              <a:t>))</a:t>
            </a:r>
          </a:p>
        </p:txBody>
      </p:sp>
      <p:sp>
        <p:nvSpPr>
          <p:cNvPr id="4" name="CuadroTexto 3"/>
          <p:cNvSpPr txBox="1"/>
          <p:nvPr/>
        </p:nvSpPr>
        <p:spPr>
          <a:xfrm rot="16200000">
            <a:off x="22345" y="2644663"/>
            <a:ext cx="46307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Total </a:t>
            </a:r>
            <a:r>
              <a:rPr lang="en-US" sz="2400" dirty="0"/>
              <a:t>Adiponectin</a:t>
            </a:r>
            <a:r>
              <a:rPr lang="es-CL" sz="2400" dirty="0"/>
              <a:t> (µ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8030819" y="1073426"/>
            <a:ext cx="15372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-0.29</a:t>
            </a:r>
          </a:p>
          <a:p>
            <a:r>
              <a:rPr lang="es-CL" dirty="0"/>
              <a:t>p= 0.0236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2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188004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9325" y="647700"/>
            <a:ext cx="7753350" cy="55626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5380382" y="5748635"/>
            <a:ext cx="267694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BMI (Kg/m</a:t>
            </a:r>
            <a:r>
              <a:rPr lang="es-CL" sz="2400" baseline="30000" dirty="0"/>
              <a:t>2</a:t>
            </a:r>
            <a:r>
              <a:rPr lang="es-CL" sz="2400" dirty="0"/>
              <a:t>))</a:t>
            </a:r>
          </a:p>
        </p:txBody>
      </p:sp>
      <p:sp>
        <p:nvSpPr>
          <p:cNvPr id="4" name="CuadroTexto 3"/>
          <p:cNvSpPr txBox="1"/>
          <p:nvPr/>
        </p:nvSpPr>
        <p:spPr>
          <a:xfrm rot="16200000">
            <a:off x="22345" y="2084553"/>
            <a:ext cx="46307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HMWA (µ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8150087" y="980661"/>
            <a:ext cx="12589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-0.23</a:t>
            </a:r>
          </a:p>
          <a:p>
            <a:r>
              <a:rPr lang="es-CL" dirty="0"/>
              <a:t>p= 0.0801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2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12714189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4562" y="657225"/>
            <a:ext cx="7762875" cy="554355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5300868" y="5739110"/>
            <a:ext cx="267694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BMI (Kg/m</a:t>
            </a:r>
            <a:r>
              <a:rPr lang="es-CL" sz="2400" baseline="30000" dirty="0"/>
              <a:t>2</a:t>
            </a:r>
            <a:r>
              <a:rPr lang="es-CL" sz="2400" dirty="0"/>
              <a:t>))</a:t>
            </a:r>
          </a:p>
        </p:txBody>
      </p:sp>
      <p:sp>
        <p:nvSpPr>
          <p:cNvPr id="4" name="CuadroTexto 3"/>
          <p:cNvSpPr txBox="1"/>
          <p:nvPr/>
        </p:nvSpPr>
        <p:spPr>
          <a:xfrm rot="16200000">
            <a:off x="835472" y="2784722"/>
            <a:ext cx="296848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Log (</a:t>
            </a:r>
            <a:r>
              <a:rPr lang="en-US" sz="2400" dirty="0"/>
              <a:t>Leptin</a:t>
            </a:r>
            <a:r>
              <a:rPr lang="es-CL" sz="2400" dirty="0"/>
              <a:t> (ng/ml))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8791152" y="884979"/>
            <a:ext cx="13119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r= 0.59</a:t>
            </a:r>
          </a:p>
          <a:p>
            <a:r>
              <a:rPr lang="es-CL" dirty="0"/>
              <a:t>p &lt; 0,0001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2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12245873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Panorámica</PresentationFormat>
  <Paragraphs>15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ito Bravo</dc:creator>
  <cp:lastModifiedBy>Carito Bravo</cp:lastModifiedBy>
  <cp:revision>1</cp:revision>
  <dcterms:created xsi:type="dcterms:W3CDTF">2017-03-27T14:46:25Z</dcterms:created>
  <dcterms:modified xsi:type="dcterms:W3CDTF">2017-03-27T14:46:42Z</dcterms:modified>
</cp:coreProperties>
</file>